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gif" ContentType="image/gi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1" r:id="rId2"/>
    <p:sldId id="256" r:id="rId3"/>
    <p:sldId id="257" r:id="rId4"/>
    <p:sldId id="258" r:id="rId5"/>
    <p:sldId id="259" r:id="rId6"/>
    <p:sldId id="261" r:id="rId7"/>
    <p:sldId id="262" r:id="rId8"/>
    <p:sldId id="263" r:id="rId9"/>
    <p:sldId id="264" r:id="rId10"/>
    <p:sldId id="265" r:id="rId11"/>
    <p:sldId id="270" r:id="rId12"/>
    <p:sldId id="266" r:id="rId13"/>
    <p:sldId id="267" r:id="rId14"/>
    <p:sldId id="268" r:id="rId15"/>
    <p:sldId id="269" r:id="rId16"/>
    <p:sldId id="260" r:id="rId17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14" d="100"/>
          <a:sy n="114" d="100"/>
        </p:scale>
        <p:origin x="-906" y="-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3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3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3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3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3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30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30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30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30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30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30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0/3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gif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gif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gif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gif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gif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gif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gif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gi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gi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gi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gi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gi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gi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gi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g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362" name="Picture 2" descr="http://multalin.toulouse.inra.fr/multalin/result/1414610514.gif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1000" y="609600"/>
            <a:ext cx="8442888" cy="36417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91286062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18" name="Picture 2" descr="http://multalin.toulouse.inra.fr/multalin/result/1414587694.gif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2400" y="1002890"/>
            <a:ext cx="8886825" cy="447208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31939913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338" name="Picture 2" descr="http://multalin.toulouse.inra.fr/multalin/result/1414591707.gif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" y="457200"/>
            <a:ext cx="8902415" cy="44799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998882431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42" name="Picture 2" descr="http://multalin.toulouse.inra.fr/multalin/result/1414588292.gif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" y="1676400"/>
            <a:ext cx="9067800" cy="260751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69748705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68" name="Picture 4" descr="http://multalin.toulouse.inra.fr/multalin/result/1414589070.gif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2400" y="914400"/>
            <a:ext cx="8582025" cy="370174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279096734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292" name="Picture 4" descr="http://multalin.toulouse.inra.fr/multalin/result/1414589780.gif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" y="1295400"/>
            <a:ext cx="8874125" cy="255182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44904374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314" name="Picture 2" descr="http://multalin.toulouse.inra.fr/multalin/result/1414590138.gif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58" y="838200"/>
            <a:ext cx="9102725" cy="327194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873654683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905000" y="0"/>
            <a:ext cx="4572000" cy="286232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/>
              <a:t>&gt;</a:t>
            </a:r>
            <a:r>
              <a:rPr lang="en-US" dirty="0" err="1"/>
              <a:t>rf</a:t>
            </a:r>
            <a:r>
              <a:rPr lang="en-US" dirty="0"/>
              <a:t> 1 Seq7 [organism=</a:t>
            </a:r>
            <a:r>
              <a:rPr lang="en-US" dirty="0" err="1"/>
              <a:t>Globodera</a:t>
            </a:r>
            <a:r>
              <a:rPr lang="en-US" dirty="0"/>
              <a:t> </a:t>
            </a:r>
            <a:r>
              <a:rPr lang="en-US" dirty="0" err="1"/>
              <a:t>rostochiensis</a:t>
            </a:r>
            <a:r>
              <a:rPr lang="en-US" dirty="0"/>
              <a:t>] VAP1 mRNA (</a:t>
            </a:r>
            <a:r>
              <a:rPr lang="en-US" dirty="0" err="1"/>
              <a:t>GenBank</a:t>
            </a:r>
            <a:r>
              <a:rPr lang="en-US" dirty="0"/>
              <a:t>: KF963519.1) MAFAPTISVLCLLLIALSEMPFSVLALSASSRVSVLACHNNYRSTLAKGTAANLTGTMPA GSNLIQQKYSTSAETTAQNWANGCSMAHSSSSSRNGMGENLYMTSSSTITEADALKQACD MWWAELKQYGFQSSLVLDMNQFNKGIGHWSQQAWANTAQLGCAMARCPSSTWKTWVVCNY NASGNYLNQVVYKKGTACSGCSDYSGASCNSTSGLCVLP* </a:t>
            </a:r>
          </a:p>
        </p:txBody>
      </p:sp>
      <p:sp>
        <p:nvSpPr>
          <p:cNvPr id="4" name="Rectangle 3"/>
          <p:cNvSpPr/>
          <p:nvPr/>
        </p:nvSpPr>
        <p:spPr>
          <a:xfrm>
            <a:off x="1828800" y="3276600"/>
            <a:ext cx="4572000" cy="2308324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/>
              <a:t>&gt;</a:t>
            </a:r>
            <a:r>
              <a:rPr lang="en-US" dirty="0" err="1"/>
              <a:t>rf</a:t>
            </a:r>
            <a:r>
              <a:rPr lang="en-US" dirty="0"/>
              <a:t> 1 (VAP1)-mRNA-</a:t>
            </a:r>
            <a:r>
              <a:rPr lang="en-US" dirty="0" err="1"/>
              <a:t>completecds</a:t>
            </a:r>
            <a:r>
              <a:rPr lang="en-US" dirty="0"/>
              <a:t>-New version 2011NCBI MAFAPTISVLCLLLIALSEMPFSVLALSASSRVSVLACHNNYRSTLAKGTAANLTGTMPA GSNLIQQKYSTSAETTAQNWANGCSMAHSSSSSRNGMGENLYMTSSSTITEADALKQACD MWWAELKQYGFQSSLVLDMNQFNKGIGHWSQQAWANTAQLGCAMARCPSSTWKTWVVCNY NASG </a:t>
            </a:r>
          </a:p>
        </p:txBody>
      </p:sp>
    </p:spTree>
    <p:extLst>
      <p:ext uri="{BB962C8B-B14F-4D97-AF65-F5344CB8AC3E}">
        <p14:creationId xmlns:p14="http://schemas.microsoft.com/office/powerpoint/2010/main" val="32534228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http://multalin.toulouse.inra.fr/multalin/result/1414572565.gif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4800" y="1135661"/>
            <a:ext cx="8610600" cy="371406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22103998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2" name="Picture 4" descr="http://multalin.toulouse.inra.fr/multalin/result/1414574062.gif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25523" y="186112"/>
            <a:ext cx="6939002" cy="59860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34410414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http://multalin.toulouse.inra.fr/multalin/result/1414573843.gif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3400" y="381000"/>
            <a:ext cx="7924800" cy="569709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35973461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 descr="http://multalin.toulouse.inra.fr/multalin/result/1414574871.gif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" y="685800"/>
            <a:ext cx="8797925" cy="50598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64697880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 descr="http://multalin.toulouse.inra.fr/multalin/result/1414581437.gif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993725"/>
            <a:ext cx="8763000" cy="37798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45627540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 descr="http://multalin.toulouse.inra.fr/multalin/result/1414582792.gif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4800" y="1143000"/>
            <a:ext cx="8569325" cy="431230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82278124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 descr="http://multalin.toulouse.inra.fr/multalin/result/1414583364.gif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4800" y="1066800"/>
            <a:ext cx="8654806" cy="373313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35803572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Picture 2" descr="http://multalin.toulouse.inra.fr/multalin/result/1414583918.gif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49669" y="152400"/>
            <a:ext cx="5754078" cy="57912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9842357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30</TotalTime>
  <Words>33</Words>
  <Application>Microsoft Office PowerPoint</Application>
  <PresentationFormat>On-screen Show (4:3)</PresentationFormat>
  <Paragraphs>2</Paragraphs>
  <Slides>16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6</vt:i4>
      </vt:variant>
    </vt:vector>
  </HeadingPairs>
  <TitlesOfParts>
    <vt:vector size="17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awkat Ali</dc:creator>
  <cp:lastModifiedBy>Peter Moffett</cp:lastModifiedBy>
  <cp:revision>18</cp:revision>
  <dcterms:created xsi:type="dcterms:W3CDTF">2006-08-16T00:00:00Z</dcterms:created>
  <dcterms:modified xsi:type="dcterms:W3CDTF">2014-10-30T14:54:50Z</dcterms:modified>
</cp:coreProperties>
</file>